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1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 autoAdjust="0"/>
    <p:restoredTop sz="94576" autoAdjust="0"/>
  </p:normalViewPr>
  <p:slideViewPr>
    <p:cSldViewPr>
      <p:cViewPr>
        <p:scale>
          <a:sx n="110" d="100"/>
          <a:sy n="110" d="100"/>
        </p:scale>
        <p:origin x="-792" y="-84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3492C-C387-406D-A7F1-6F69C030CD75}" type="datetimeFigureOut">
              <a:rPr lang="en-US" smtClean="0"/>
              <a:pPr/>
              <a:t>7/6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96C6D6-EBFE-4B09-A3A2-71B9DC58F78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3492C-C387-406D-A7F1-6F69C030CD75}" type="datetimeFigureOut">
              <a:rPr lang="en-US" smtClean="0"/>
              <a:pPr/>
              <a:t>7/6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96C6D6-EBFE-4B09-A3A2-71B9DC58F78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3492C-C387-406D-A7F1-6F69C030CD75}" type="datetimeFigureOut">
              <a:rPr lang="en-US" smtClean="0"/>
              <a:pPr/>
              <a:t>7/6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96C6D6-EBFE-4B09-A3A2-71B9DC58F78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3492C-C387-406D-A7F1-6F69C030CD75}" type="datetimeFigureOut">
              <a:rPr lang="en-US" smtClean="0"/>
              <a:pPr/>
              <a:t>7/6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96C6D6-EBFE-4B09-A3A2-71B9DC58F78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3492C-C387-406D-A7F1-6F69C030CD75}" type="datetimeFigureOut">
              <a:rPr lang="en-US" smtClean="0"/>
              <a:pPr/>
              <a:t>7/6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96C6D6-EBFE-4B09-A3A2-71B9DC58F78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3492C-C387-406D-A7F1-6F69C030CD75}" type="datetimeFigureOut">
              <a:rPr lang="en-US" smtClean="0"/>
              <a:pPr/>
              <a:t>7/6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96C6D6-EBFE-4B09-A3A2-71B9DC58F78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3492C-C387-406D-A7F1-6F69C030CD75}" type="datetimeFigureOut">
              <a:rPr lang="en-US" smtClean="0"/>
              <a:pPr/>
              <a:t>7/6/201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96C6D6-EBFE-4B09-A3A2-71B9DC58F78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3492C-C387-406D-A7F1-6F69C030CD75}" type="datetimeFigureOut">
              <a:rPr lang="en-US" smtClean="0"/>
              <a:pPr/>
              <a:t>7/6/201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96C6D6-EBFE-4B09-A3A2-71B9DC58F78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3492C-C387-406D-A7F1-6F69C030CD75}" type="datetimeFigureOut">
              <a:rPr lang="en-US" smtClean="0"/>
              <a:pPr/>
              <a:t>7/6/201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96C6D6-EBFE-4B09-A3A2-71B9DC58F78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3492C-C387-406D-A7F1-6F69C030CD75}" type="datetimeFigureOut">
              <a:rPr lang="en-US" smtClean="0"/>
              <a:pPr/>
              <a:t>7/6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96C6D6-EBFE-4B09-A3A2-71B9DC58F78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3492C-C387-406D-A7F1-6F69C030CD75}" type="datetimeFigureOut">
              <a:rPr lang="en-US" smtClean="0"/>
              <a:pPr/>
              <a:t>7/6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96C6D6-EBFE-4B09-A3A2-71B9DC58F78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63492C-C387-406D-A7F1-6F69C030CD75}" type="datetimeFigureOut">
              <a:rPr lang="en-US" smtClean="0"/>
              <a:pPr/>
              <a:t>7/6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96C6D6-EBFE-4B09-A3A2-71B9DC58F781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ontent Placeholder 3"/>
          <p:cNvGraphicFramePr>
            <a:graphicFrameLocks noGrp="1"/>
          </p:cNvGraphicFramePr>
          <p:nvPr>
            <p:ph idx="1"/>
          </p:nvPr>
        </p:nvGraphicFramePr>
        <p:xfrm>
          <a:off x="0" y="381000"/>
          <a:ext cx="6858001" cy="8706424"/>
        </p:xfrm>
        <a:graphic>
          <a:graphicData uri="http://schemas.openxmlformats.org/drawingml/2006/table">
            <a:tbl>
              <a:tblPr/>
              <a:tblGrid>
                <a:gridCol w="1221623"/>
                <a:gridCol w="1557623"/>
                <a:gridCol w="596349"/>
                <a:gridCol w="767686"/>
                <a:gridCol w="356030"/>
                <a:gridCol w="427235"/>
                <a:gridCol w="427235"/>
                <a:gridCol w="391631"/>
                <a:gridCol w="453937"/>
                <a:gridCol w="658652"/>
              </a:tblGrid>
              <a:tr h="22169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 dirty="0">
                          <a:latin typeface="Arial"/>
                        </a:rPr>
                        <a:t>Peptide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latin typeface="Arial"/>
                        </a:rPr>
                        <a:t>Protein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latin typeface="Arial"/>
                        </a:rPr>
                        <a:t>Influenza strain 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latin typeface="Arial"/>
                        </a:rPr>
                        <a:t>Accession ID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latin typeface="Arial"/>
                        </a:rPr>
                        <a:t>Motif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latin typeface="Arial"/>
                        </a:rPr>
                        <a:t>m/z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latin typeface="Arial"/>
                        </a:rPr>
                        <a:t>Charge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latin typeface="Arial"/>
                        </a:rPr>
                        <a:t>Xcorr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latin typeface="Arial"/>
                        </a:rPr>
                        <a:t>Score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1792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latin typeface="Arial"/>
                        </a:rPr>
                        <a:t> 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latin typeface="Arial"/>
                        </a:rPr>
                        <a:t> 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latin typeface="Arial"/>
                        </a:rPr>
                        <a:t> 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latin typeface="Arial"/>
                        </a:rPr>
                        <a:t> 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latin typeface="Arial"/>
                        </a:rPr>
                        <a:t> 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latin typeface="Arial"/>
                        </a:rPr>
                        <a:t> 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latin typeface="Arial"/>
                        </a:rPr>
                        <a:t> 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latin typeface="Arial"/>
                        </a:rPr>
                        <a:t> 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latin typeface="Arial"/>
                        </a:rPr>
                        <a:t>Bimas</a:t>
                      </a:r>
                      <a:r>
                        <a:rPr lang="en-US" sz="600" b="1" i="0" u="none" strike="noStrike" baseline="30000">
                          <a:latin typeface="Arial"/>
                        </a:rPr>
                        <a:t>†</a:t>
                      </a:r>
                      <a:endParaRPr lang="en-US" sz="600" b="1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latin typeface="Arial"/>
                        </a:rPr>
                        <a:t>SYFPEITHI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95283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latin typeface="Arial"/>
                        </a:rPr>
                        <a:t>YINTALLNA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latin typeface="Arial"/>
                        </a:rPr>
                        <a:t>polymerase PA 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H5N1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gi168805480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A2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496.8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2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1.8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7.2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20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95283">
                <a:tc>
                  <a:txBody>
                    <a:bodyPr/>
                    <a:lstStyle/>
                    <a:p>
                      <a:pPr algn="l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latin typeface="Arial"/>
                        </a:rPr>
                        <a:t>polymerase PA 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H1N1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latin typeface="Arial"/>
                        </a:rPr>
                        <a:t>A3DRP7</a:t>
                      </a:r>
                    </a:p>
                  </a:txBody>
                  <a:tcPr marL="3277" marR="3277" marT="32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283">
                <a:tc>
                  <a:txBody>
                    <a:bodyPr/>
                    <a:lstStyle/>
                    <a:p>
                      <a:pPr algn="l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latin typeface="Arial"/>
                        </a:rPr>
                        <a:t>polymerase PA 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H3N2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latin typeface="Arial"/>
                        </a:rPr>
                        <a:t>O91742</a:t>
                      </a:r>
                    </a:p>
                  </a:txBody>
                  <a:tcPr marL="3277" marR="3277" marT="32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283">
                <a:tc>
                  <a:txBody>
                    <a:bodyPr/>
                    <a:lstStyle/>
                    <a:p>
                      <a:pPr algn="l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latin typeface="Arial"/>
                        </a:rPr>
                        <a:t>polymerase PA 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H3N8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latin typeface="Arial"/>
                        </a:rPr>
                        <a:t>P13169</a:t>
                      </a:r>
                    </a:p>
                  </a:txBody>
                  <a:tcPr marL="3277" marR="3277" marT="32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283">
                <a:tc>
                  <a:txBody>
                    <a:bodyPr/>
                    <a:lstStyle/>
                    <a:p>
                      <a:pPr algn="l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latin typeface="Arial"/>
                        </a:rPr>
                        <a:t>polymerase PA 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H4N6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latin typeface="Arial"/>
                        </a:rPr>
                        <a:t>P13172</a:t>
                      </a:r>
                    </a:p>
                  </a:txBody>
                  <a:tcPr marL="3277" marR="3277" marT="32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283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latin typeface="Arial"/>
                        </a:rPr>
                        <a:t>TVIKTNMI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latin typeface="Arial"/>
                        </a:rPr>
                        <a:t>polymerase PB1 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H5N1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gi172053048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A2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460.3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2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2.1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▬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▬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283">
                <a:tc>
                  <a:txBody>
                    <a:bodyPr/>
                    <a:lstStyle/>
                    <a:p>
                      <a:pPr algn="l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latin typeface="Arial"/>
                        </a:rPr>
                        <a:t>PB1 polymerase subunit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H9N2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latin typeface="Arial"/>
                        </a:rPr>
                        <a:t>Q9Q0S3</a:t>
                      </a:r>
                    </a:p>
                  </a:txBody>
                  <a:tcPr marL="3277" marR="3277" marT="32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8680">
                <a:tc>
                  <a:txBody>
                    <a:bodyPr/>
                    <a:lstStyle/>
                    <a:p>
                      <a:pPr algn="l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 dirty="0">
                          <a:latin typeface="Arial"/>
                        </a:rPr>
                        <a:t>RNA-directed RNA polymerase catalytic subunit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H7N3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latin typeface="Arial"/>
                        </a:rPr>
                        <a:t>E9P6L9</a:t>
                      </a:r>
                    </a:p>
                  </a:txBody>
                  <a:tcPr marL="3277" marR="3277" marT="32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8680">
                <a:tc>
                  <a:txBody>
                    <a:bodyPr/>
                    <a:lstStyle/>
                    <a:p>
                      <a:pPr algn="l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latin typeface="Arial"/>
                        </a:rPr>
                        <a:t>RNA-directed RNA polymerase catalytic subunit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H1N1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latin typeface="Arial"/>
                        </a:rPr>
                        <a:t>A6M777</a:t>
                      </a:r>
                    </a:p>
                  </a:txBody>
                  <a:tcPr marL="3277" marR="3277" marT="32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283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latin typeface="Arial"/>
                        </a:rPr>
                        <a:t>PVAGGTSSIYI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latin typeface="Arial"/>
                        </a:rPr>
                        <a:t>polymerase PB2 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H3N2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gi215480628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A2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603.3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2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2.4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1.4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19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283">
                <a:tc>
                  <a:txBody>
                    <a:bodyPr/>
                    <a:lstStyle/>
                    <a:p>
                      <a:pPr algn="l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latin typeface="Arial"/>
                        </a:rPr>
                        <a:t>polymerase PB2 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H1N2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Q75TA1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283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latin typeface="Arial"/>
                        </a:rPr>
                        <a:t>MTIIFLILM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latin typeface="Arial"/>
                        </a:rPr>
                        <a:t>hemagglutinin 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H2N3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gi257123295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A2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1094.6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1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1.7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1.0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15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283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latin typeface="Arial"/>
                        </a:rPr>
                        <a:t>AIMDKNIIL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latin typeface="Arial"/>
                        </a:rPr>
                        <a:t>nonstructural protein 1 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H1N1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gi138898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A2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515.8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2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2.1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18.3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23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283">
                <a:tc>
                  <a:txBody>
                    <a:bodyPr/>
                    <a:lstStyle/>
                    <a:p>
                      <a:pPr algn="l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latin typeface="Arial"/>
                        </a:rPr>
                        <a:t>nonstructural protein 1 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H3N8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latin typeface="Arial"/>
                        </a:rPr>
                        <a:t>Q77ZM3</a:t>
                      </a:r>
                    </a:p>
                  </a:txBody>
                  <a:tcPr marL="3277" marR="3277" marT="32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283">
                <a:tc>
                  <a:txBody>
                    <a:bodyPr/>
                    <a:lstStyle/>
                    <a:p>
                      <a:pPr algn="l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latin typeface="Arial"/>
                        </a:rPr>
                        <a:t>nonstructural protein 1 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H2N8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latin typeface="Arial"/>
                        </a:rPr>
                        <a:t>O57276</a:t>
                      </a:r>
                    </a:p>
                  </a:txBody>
                  <a:tcPr marL="3277" marR="3277" marT="32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283">
                <a:tc>
                  <a:txBody>
                    <a:bodyPr/>
                    <a:lstStyle/>
                    <a:p>
                      <a:pPr algn="l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latin typeface="Arial"/>
                        </a:rPr>
                        <a:t>nonstructural protein 1 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H5N9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latin typeface="Arial"/>
                        </a:rPr>
                        <a:t>O41649</a:t>
                      </a:r>
                    </a:p>
                  </a:txBody>
                  <a:tcPr marL="3277" marR="3277" marT="32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283">
                <a:tc>
                  <a:txBody>
                    <a:bodyPr/>
                    <a:lstStyle/>
                    <a:p>
                      <a:pPr algn="l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latin typeface="Arial"/>
                        </a:rPr>
                        <a:t>nonstructural protein 1 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H4N6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latin typeface="Arial"/>
                        </a:rPr>
                        <a:t>Q6LDH2</a:t>
                      </a:r>
                    </a:p>
                  </a:txBody>
                  <a:tcPr marL="3277" marR="3277" marT="32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283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latin typeface="Arial"/>
                        </a:rPr>
                        <a:t>AINGITNKV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latin typeface="Arial"/>
                        </a:rPr>
                        <a:t>Hemagglutinin  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H1N1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P03452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A2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465.3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2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2.6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9.6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28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283">
                <a:tc>
                  <a:txBody>
                    <a:bodyPr/>
                    <a:lstStyle/>
                    <a:p>
                      <a:pPr algn="l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latin typeface="Arial"/>
                        </a:rPr>
                        <a:t>Hemagglutinin  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H1N2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latin typeface="Arial"/>
                        </a:rPr>
                        <a:t>Q9YTC2</a:t>
                      </a:r>
                    </a:p>
                  </a:txBody>
                  <a:tcPr marL="3277" marR="3277" marT="32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283">
                <a:tc>
                  <a:txBody>
                    <a:bodyPr/>
                    <a:lstStyle/>
                    <a:p>
                      <a:pPr algn="l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latin typeface="Arial"/>
                        </a:rPr>
                        <a:t>Hemagglutinin  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H1N9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latin typeface="Arial"/>
                        </a:rPr>
                        <a:t>Q82544</a:t>
                      </a:r>
                    </a:p>
                  </a:txBody>
                  <a:tcPr marL="3277" marR="3277" marT="32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8680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latin typeface="Arial"/>
                        </a:rPr>
                        <a:t>EEmGITTHF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latin typeface="Arial"/>
                        </a:rPr>
                        <a:t>RNA-directed RNA polymerase catalytic subunit  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H1N1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A4GCJ4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B44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540.7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2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2.0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270.0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26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8680">
                <a:tc>
                  <a:txBody>
                    <a:bodyPr/>
                    <a:lstStyle/>
                    <a:p>
                      <a:pPr algn="l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latin typeface="Arial"/>
                        </a:rPr>
                        <a:t>RNA-directed RNA polymerase catalytic subunit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H3N2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latin typeface="Arial"/>
                        </a:rPr>
                        <a:t>Q9IQ46</a:t>
                      </a:r>
                    </a:p>
                  </a:txBody>
                  <a:tcPr marL="3277" marR="3277" marT="32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283">
                <a:tc>
                  <a:txBody>
                    <a:bodyPr/>
                    <a:lstStyle/>
                    <a:p>
                      <a:pPr algn="l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latin typeface="Arial"/>
                        </a:rPr>
                        <a:t>Polymerase subunit 1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H1N2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latin typeface="Arial"/>
                        </a:rPr>
                        <a:t>Q8QM24</a:t>
                      </a:r>
                    </a:p>
                  </a:txBody>
                  <a:tcPr marL="3277" marR="3277" marT="32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283">
                <a:tc>
                  <a:txBody>
                    <a:bodyPr/>
                    <a:lstStyle/>
                    <a:p>
                      <a:pPr algn="l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latin typeface="Arial"/>
                        </a:rPr>
                        <a:t>Polymerase (Fragment) 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H9N2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latin typeface="Arial"/>
                        </a:rPr>
                        <a:t>Q7TGZ8</a:t>
                      </a:r>
                    </a:p>
                  </a:txBody>
                  <a:tcPr marL="3277" marR="3277" marT="32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8680">
                <a:tc>
                  <a:txBody>
                    <a:bodyPr/>
                    <a:lstStyle/>
                    <a:p>
                      <a:pPr algn="l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latin typeface="Arial"/>
                        </a:rPr>
                        <a:t>RNA-directed RNA polymerase catalytic subunit 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H8N4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latin typeface="Arial"/>
                        </a:rPr>
                        <a:t>Q20S02</a:t>
                      </a:r>
                    </a:p>
                  </a:txBody>
                  <a:tcPr marL="3277" marR="3277" marT="32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283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latin typeface="Arial"/>
                        </a:rPr>
                        <a:t>VETPIRNEW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latin typeface="Arial"/>
                        </a:rPr>
                        <a:t>Matrix protein 2  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H13N6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Q0A415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B44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572.3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2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2.8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24.0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26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283">
                <a:tc>
                  <a:txBody>
                    <a:bodyPr/>
                    <a:lstStyle/>
                    <a:p>
                      <a:pPr algn="l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latin typeface="Arial"/>
                        </a:rPr>
                        <a:t>Matrix protein 2  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H1N1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latin typeface="Arial"/>
                        </a:rPr>
                        <a:t>Q07FI4</a:t>
                      </a:r>
                    </a:p>
                  </a:txBody>
                  <a:tcPr marL="3277" marR="3277" marT="32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8680">
                <a:tc>
                  <a:txBody>
                    <a:bodyPr/>
                    <a:lstStyle/>
                    <a:p>
                      <a:pPr algn="l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latin typeface="Arial"/>
                        </a:rPr>
                        <a:t>Matrix protein 2 (Proton channel protein M2)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H3N2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latin typeface="Arial"/>
                        </a:rPr>
                        <a:t>Q77GW2</a:t>
                      </a:r>
                    </a:p>
                  </a:txBody>
                  <a:tcPr marL="3277" marR="3277" marT="32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8680">
                <a:tc>
                  <a:txBody>
                    <a:bodyPr/>
                    <a:lstStyle/>
                    <a:p>
                      <a:pPr algn="l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 dirty="0">
                          <a:latin typeface="Arial"/>
                        </a:rPr>
                        <a:t>Matrix protein 2 (Proton channel protein M2)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H2N2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latin typeface="Arial"/>
                        </a:rPr>
                        <a:t>Q77IM6</a:t>
                      </a:r>
                    </a:p>
                  </a:txBody>
                  <a:tcPr marL="3277" marR="3277" marT="32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283">
                <a:tc>
                  <a:txBody>
                    <a:bodyPr/>
                    <a:lstStyle/>
                    <a:p>
                      <a:pPr algn="l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latin typeface="Arial"/>
                        </a:rPr>
                        <a:t>Matrix protein 2  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H2N1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latin typeface="Arial"/>
                        </a:rPr>
                        <a:t>Q997A8</a:t>
                      </a:r>
                    </a:p>
                  </a:txBody>
                  <a:tcPr marL="3277" marR="3277" marT="32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283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latin typeface="Arial"/>
                        </a:rPr>
                        <a:t>REILTKTTV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latin typeface="Arial"/>
                        </a:rPr>
                        <a:t>Polymerase basic protein 2  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H4N2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P26112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B44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530.8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2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2.4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30.0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15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283">
                <a:tc>
                  <a:txBody>
                    <a:bodyPr/>
                    <a:lstStyle/>
                    <a:p>
                      <a:pPr algn="l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latin typeface="Arial"/>
                        </a:rPr>
                        <a:t>Polymerase basic protein 2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H5N1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latin typeface="Arial"/>
                        </a:rPr>
                        <a:t>O56266</a:t>
                      </a:r>
                    </a:p>
                  </a:txBody>
                  <a:tcPr marL="3277" marR="3277" marT="32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283">
                <a:tc>
                  <a:txBody>
                    <a:bodyPr/>
                    <a:lstStyle/>
                    <a:p>
                      <a:pPr algn="l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latin typeface="Arial"/>
                        </a:rPr>
                        <a:t>Polymerase basic protein 2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H1N1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latin typeface="Arial"/>
                        </a:rPr>
                        <a:t>Q07FH5</a:t>
                      </a:r>
                    </a:p>
                  </a:txBody>
                  <a:tcPr marL="3277" marR="3277" marT="32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283">
                <a:tc>
                  <a:txBody>
                    <a:bodyPr/>
                    <a:lstStyle/>
                    <a:p>
                      <a:pPr algn="l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latin typeface="Arial"/>
                        </a:rPr>
                        <a:t>Polymerase basic protein 2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H3N2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latin typeface="Arial"/>
                        </a:rPr>
                        <a:t>O91740</a:t>
                      </a:r>
                    </a:p>
                  </a:txBody>
                  <a:tcPr marL="3277" marR="3277" marT="32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283">
                <a:tc>
                  <a:txBody>
                    <a:bodyPr/>
                    <a:lstStyle/>
                    <a:p>
                      <a:pPr algn="l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latin typeface="Arial"/>
                        </a:rPr>
                        <a:t>Polymerase basic protein 2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H3N8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latin typeface="Arial"/>
                        </a:rPr>
                        <a:t>P26105</a:t>
                      </a:r>
                    </a:p>
                  </a:txBody>
                  <a:tcPr marL="3277" marR="3277" marT="32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283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latin typeface="Arial"/>
                        </a:rPr>
                        <a:t>KESDEALNmTMASTP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latin typeface="Arial"/>
                        </a:rPr>
                        <a:t>nonstructural protein 1 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H3N2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gi110733621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B44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820.9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2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2.3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36.0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15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283">
                <a:tc>
                  <a:txBody>
                    <a:bodyPr/>
                    <a:lstStyle/>
                    <a:p>
                      <a:pPr algn="l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latin typeface="Arial"/>
                        </a:rPr>
                        <a:t>Non-structural protein NS1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H2N2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latin typeface="Arial"/>
                        </a:rPr>
                        <a:t>Q6XTI6</a:t>
                      </a:r>
                    </a:p>
                  </a:txBody>
                  <a:tcPr marL="3277" marR="3277" marT="32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283">
                <a:tc>
                  <a:txBody>
                    <a:bodyPr/>
                    <a:lstStyle/>
                    <a:p>
                      <a:pPr algn="l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latin typeface="Arial"/>
                        </a:rPr>
                        <a:t>hemagglutinin 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H1N1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gi254923228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283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latin typeface="Arial"/>
                        </a:rPr>
                        <a:t>KESDEALNmTMASTP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latin typeface="Arial"/>
                        </a:rPr>
                        <a:t>hemagglutinin 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H1N1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gi254923228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B44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820.9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2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2.3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36.0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15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283">
                <a:tc>
                  <a:txBody>
                    <a:bodyPr/>
                    <a:lstStyle/>
                    <a:p>
                      <a:pPr algn="l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latin typeface="Arial"/>
                        </a:rPr>
                        <a:t>nonstructural protein 1 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H3N2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gi110733621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283">
                <a:tc>
                  <a:txBody>
                    <a:bodyPr/>
                    <a:lstStyle/>
                    <a:p>
                      <a:pPr algn="l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latin typeface="Arial"/>
                        </a:rPr>
                        <a:t>Non-structural protein NS1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H2N2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latin typeface="Arial"/>
                        </a:rPr>
                        <a:t>Q6XTI6</a:t>
                      </a:r>
                    </a:p>
                  </a:txBody>
                  <a:tcPr marL="3277" marR="3277" marT="32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283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latin typeface="Arial"/>
                        </a:rPr>
                        <a:t>EESDEALKMSmASTP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latin typeface="Arial"/>
                        </a:rPr>
                        <a:t>Non-structural protein 1  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H3N2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Q2VNE7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B44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821.3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2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2.3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24.0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17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283">
                <a:tc>
                  <a:txBody>
                    <a:bodyPr/>
                    <a:lstStyle/>
                    <a:p>
                      <a:pPr algn="l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latin typeface="Arial"/>
                        </a:rPr>
                        <a:t>Non-structural protein NS1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H2N2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latin typeface="Arial"/>
                        </a:rPr>
                        <a:t>Q6XTI6</a:t>
                      </a:r>
                    </a:p>
                  </a:txBody>
                  <a:tcPr marL="3277" marR="3277" marT="32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283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latin typeface="Arial"/>
                        </a:rPr>
                        <a:t>LENERTLDF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latin typeface="Arial"/>
                        </a:rPr>
                        <a:t>Polymerase acidic protein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H5N2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Q0A2I0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B44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568.8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2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2.3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60.0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23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283">
                <a:tc>
                  <a:txBody>
                    <a:bodyPr/>
                    <a:lstStyle/>
                    <a:p>
                      <a:pPr algn="l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latin typeface="Arial"/>
                        </a:rPr>
                        <a:t>Hemagglutinin precursor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H1N1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latin typeface="Arial"/>
                        </a:rPr>
                        <a:t>Q07FI5</a:t>
                      </a:r>
                    </a:p>
                  </a:txBody>
                  <a:tcPr marL="3277" marR="3277" marT="32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283">
                <a:tc>
                  <a:txBody>
                    <a:bodyPr/>
                    <a:lstStyle/>
                    <a:p>
                      <a:pPr algn="l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latin typeface="Arial"/>
                        </a:rPr>
                        <a:t>Haemagglutinin 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H1N2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latin typeface="Arial"/>
                        </a:rPr>
                        <a:t>Q9YTC1</a:t>
                      </a:r>
                    </a:p>
                  </a:txBody>
                  <a:tcPr marL="3277" marR="3277" marT="32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283">
                <a:tc>
                  <a:txBody>
                    <a:bodyPr/>
                    <a:lstStyle/>
                    <a:p>
                      <a:pPr algn="l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latin typeface="Arial"/>
                        </a:rPr>
                        <a:t>Hemagglutinin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H1N9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latin typeface="Arial"/>
                        </a:rPr>
                        <a:t>Q82544</a:t>
                      </a:r>
                    </a:p>
                  </a:txBody>
                  <a:tcPr marL="3277" marR="3277" marT="32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283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latin typeface="Arial"/>
                        </a:rPr>
                        <a:t>MEAVPLITI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latin typeface="Arial"/>
                        </a:rPr>
                        <a:t>hemagglutinin 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H9N2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gi202071398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B44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986.6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1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1.9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12.0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21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8680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latin typeface="Arial"/>
                        </a:rPr>
                        <a:t>VEQEIRTF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latin typeface="Arial"/>
                        </a:rPr>
                        <a:t>Nuclear export protein (Fragment)  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H7N7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P08275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B44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511.3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2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2.8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▬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▬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283">
                <a:tc>
                  <a:txBody>
                    <a:bodyPr/>
                    <a:lstStyle/>
                    <a:p>
                      <a:pPr algn="l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latin typeface="Arial"/>
                        </a:rPr>
                        <a:t>Nuclear export protein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H5N1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latin typeface="Arial"/>
                        </a:rPr>
                        <a:t>O56263</a:t>
                      </a:r>
                    </a:p>
                  </a:txBody>
                  <a:tcPr marL="3277" marR="3277" marT="32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283">
                <a:tc>
                  <a:txBody>
                    <a:bodyPr/>
                    <a:lstStyle/>
                    <a:p>
                      <a:pPr algn="l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latin typeface="Arial"/>
                        </a:rPr>
                        <a:t>Nuclear export protein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H1N1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latin typeface="Arial"/>
                        </a:rPr>
                        <a:t>Q07FI0</a:t>
                      </a:r>
                    </a:p>
                  </a:txBody>
                  <a:tcPr marL="3277" marR="3277" marT="32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283">
                <a:tc>
                  <a:txBody>
                    <a:bodyPr/>
                    <a:lstStyle/>
                    <a:p>
                      <a:pPr algn="l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latin typeface="Arial"/>
                        </a:rPr>
                        <a:t>Nuclear export protein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H3N8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latin typeface="Arial"/>
                        </a:rPr>
                        <a:t>Q77ZM4</a:t>
                      </a:r>
                    </a:p>
                  </a:txBody>
                  <a:tcPr marL="3277" marR="3277" marT="32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283">
                <a:tc>
                  <a:txBody>
                    <a:bodyPr/>
                    <a:lstStyle/>
                    <a:p>
                      <a:pPr algn="l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latin typeface="Arial"/>
                        </a:rPr>
                        <a:t>Nuclear export protein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H2N8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latin typeface="Arial"/>
                        </a:rPr>
                        <a:t>O57275</a:t>
                      </a:r>
                    </a:p>
                  </a:txBody>
                  <a:tcPr marL="3277" marR="3277" marT="32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283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latin typeface="Arial"/>
                        </a:rPr>
                        <a:t>VEQELRTF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latin typeface="Arial"/>
                        </a:rPr>
                        <a:t>nonstructural protein 2 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H1N1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gi156536176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B44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▬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▬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▬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▬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▬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283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latin typeface="Arial"/>
                        </a:rPr>
                        <a:t>LPFDRTTIM*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latin typeface="Arial"/>
                        </a:rPr>
                        <a:t>nucleocapsid protein 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H1N1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gi126599285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B7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555.3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2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3.4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20.0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18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283">
                <a:tc>
                  <a:txBody>
                    <a:bodyPr/>
                    <a:lstStyle/>
                    <a:p>
                      <a:pPr algn="l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latin typeface="Arial"/>
                        </a:rPr>
                        <a:t>NP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H3N2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latin typeface="Arial"/>
                        </a:rPr>
                        <a:t>Q91UL1</a:t>
                      </a:r>
                    </a:p>
                  </a:txBody>
                  <a:tcPr marL="3277" marR="3277" marT="32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283">
                <a:tc>
                  <a:txBody>
                    <a:bodyPr/>
                    <a:lstStyle/>
                    <a:p>
                      <a:pPr algn="l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latin typeface="Arial"/>
                        </a:rPr>
                        <a:t>Nucleocapsid protein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H3N1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latin typeface="Arial"/>
                        </a:rPr>
                        <a:t>B8K0Q0</a:t>
                      </a:r>
                    </a:p>
                  </a:txBody>
                  <a:tcPr marL="3277" marR="3277" marT="32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283">
                <a:tc>
                  <a:txBody>
                    <a:bodyPr/>
                    <a:lstStyle/>
                    <a:p>
                      <a:pPr algn="l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latin typeface="Arial"/>
                        </a:rPr>
                        <a:t>Nucleoprotein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H5N2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latin typeface="Arial"/>
                        </a:rPr>
                        <a:t>Q3ZFZ8</a:t>
                      </a:r>
                    </a:p>
                  </a:txBody>
                  <a:tcPr marL="3277" marR="3277" marT="32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283">
                <a:tc>
                  <a:txBody>
                    <a:bodyPr/>
                    <a:lstStyle/>
                    <a:p>
                      <a:pPr algn="l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latin typeface="Arial"/>
                        </a:rPr>
                        <a:t>Nucleocapsid protein 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H11N9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latin typeface="Arial"/>
                        </a:rPr>
                        <a:t>Q20QN4</a:t>
                      </a:r>
                    </a:p>
                  </a:txBody>
                  <a:tcPr marL="3277" marR="3277" marT="32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283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latin typeface="Arial"/>
                        </a:rPr>
                        <a:t>SPDDFALIVNA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latin typeface="Arial"/>
                        </a:rPr>
                        <a:t>polymerase PB1 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H5N1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gi224181223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B7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581.3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2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2.4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0.1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19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283">
                <a:tc>
                  <a:txBody>
                    <a:bodyPr/>
                    <a:lstStyle/>
                    <a:p>
                      <a:pPr algn="l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latin typeface="Arial"/>
                        </a:rPr>
                        <a:t>Polymerase PB1 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H4N6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latin typeface="Arial"/>
                        </a:rPr>
                        <a:t>F8IXN7</a:t>
                      </a:r>
                    </a:p>
                  </a:txBody>
                  <a:tcPr marL="3277" marR="3277" marT="32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8680">
                <a:tc>
                  <a:txBody>
                    <a:bodyPr/>
                    <a:lstStyle/>
                    <a:p>
                      <a:pPr algn="l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latin typeface="Arial"/>
                        </a:rPr>
                        <a:t>RNA-directed RNA polymerase catalytic subunit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H1N1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latin typeface="Arial"/>
                        </a:rPr>
                        <a:t>A3DRP8</a:t>
                      </a:r>
                    </a:p>
                  </a:txBody>
                  <a:tcPr marL="3277" marR="3277" marT="32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8680">
                <a:tc>
                  <a:txBody>
                    <a:bodyPr/>
                    <a:lstStyle/>
                    <a:p>
                      <a:pPr algn="l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latin typeface="Arial"/>
                        </a:rPr>
                        <a:t>RNA-directed RNA polymerase catalytic subunit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H3N2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latin typeface="Arial"/>
                        </a:rPr>
                        <a:t>O91741</a:t>
                      </a:r>
                    </a:p>
                  </a:txBody>
                  <a:tcPr marL="3277" marR="3277" marT="32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8680">
                <a:tc>
                  <a:txBody>
                    <a:bodyPr/>
                    <a:lstStyle/>
                    <a:p>
                      <a:pPr algn="l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latin typeface="Arial"/>
                        </a:rPr>
                        <a:t>RNA-directed RNA polymerase catalytic subunit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H3N8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latin typeface="Arial"/>
                        </a:rPr>
                        <a:t>P16505</a:t>
                      </a:r>
                    </a:p>
                  </a:txBody>
                  <a:tcPr marL="3277" marR="3277" marT="32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283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latin typeface="Arial"/>
                        </a:rPr>
                        <a:t>YPDTGKVM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latin typeface="Arial"/>
                        </a:rPr>
                        <a:t>Neuraminidase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H1N1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A4U7A9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B7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455.7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2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2.7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▬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▬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283">
                <a:tc>
                  <a:txBody>
                    <a:bodyPr/>
                    <a:lstStyle/>
                    <a:p>
                      <a:pPr algn="l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latin typeface="Arial"/>
                        </a:rPr>
                        <a:t>Neuraminidase (Fragment)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H3N1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latin typeface="Arial"/>
                        </a:rPr>
                        <a:t>Q4VWE2</a:t>
                      </a:r>
                    </a:p>
                  </a:txBody>
                  <a:tcPr marL="3277" marR="3277" marT="32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283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latin typeface="Arial"/>
                        </a:rPr>
                        <a:t>YPDASKVM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latin typeface="Arial"/>
                        </a:rPr>
                        <a:t>neuraminidase 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H1N1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gi157168462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B7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455.7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2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2.5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▬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▬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283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latin typeface="Arial"/>
                        </a:rPr>
                        <a:t>QPETCNQSII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latin typeface="Arial"/>
                        </a:rPr>
                        <a:t>Neuraminidase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gi128545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B7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566.8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2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2.6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2.4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16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283">
                <a:tc>
                  <a:txBody>
                    <a:bodyPr/>
                    <a:lstStyle/>
                    <a:p>
                      <a:pPr algn="l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latin typeface="Arial"/>
                        </a:rPr>
                        <a:t>Neuraminidase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H7N1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latin typeface="Arial"/>
                        </a:rPr>
                        <a:t>P06819</a:t>
                      </a:r>
                    </a:p>
                  </a:txBody>
                  <a:tcPr marL="3277" marR="3277" marT="32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283">
                <a:tc>
                  <a:txBody>
                    <a:bodyPr/>
                    <a:lstStyle/>
                    <a:p>
                      <a:pPr algn="l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latin typeface="Arial"/>
                        </a:rPr>
                        <a:t>Neuraminidase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H6N1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latin typeface="Arial"/>
                        </a:rPr>
                        <a:t>Q8UWV9</a:t>
                      </a:r>
                    </a:p>
                  </a:txBody>
                  <a:tcPr marL="3277" marR="3277" marT="32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283">
                <a:tc>
                  <a:txBody>
                    <a:bodyPr/>
                    <a:lstStyle/>
                    <a:p>
                      <a:pPr algn="l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latin typeface="Arial"/>
                        </a:rPr>
                        <a:t>Neuraminidase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H1N1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latin typeface="Arial"/>
                        </a:rPr>
                        <a:t>Q8QHT3</a:t>
                      </a:r>
                    </a:p>
                  </a:txBody>
                  <a:tcPr marL="3277" marR="3277" marT="32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283">
                <a:tc>
                  <a:txBody>
                    <a:bodyPr/>
                    <a:lstStyle/>
                    <a:p>
                      <a:pPr algn="l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latin typeface="Arial"/>
                        </a:rPr>
                        <a:t>Neuraminidase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H3N1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latin typeface="Arial"/>
                        </a:rPr>
                        <a:t>Q6XV30</a:t>
                      </a:r>
                    </a:p>
                  </a:txBody>
                  <a:tcPr marL="3277" marR="3277" marT="32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283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latin typeface="Arial"/>
                        </a:rPr>
                        <a:t>VPESKRmSL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latin typeface="Arial"/>
                        </a:rPr>
                        <a:t>nonstructural protein (NS1)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gi325258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B7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531.8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2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2.0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36.0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21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283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latin typeface="Arial"/>
                        </a:rPr>
                        <a:t> 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latin typeface="Arial"/>
                        </a:rPr>
                        <a:t> 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 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 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 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 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 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 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 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latin typeface="Arial"/>
                        </a:rPr>
                        <a:t> </a:t>
                      </a: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99056">
                <a:tc>
                  <a:txBody>
                    <a:bodyPr/>
                    <a:lstStyle/>
                    <a:p>
                      <a:pPr algn="l" fontAlgn="ctr"/>
                      <a:endParaRPr lang="en-US" sz="600" b="1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1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89623">
                <a:tc gridSpan="4"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 baseline="30000" dirty="0">
                          <a:latin typeface="Arial"/>
                        </a:rPr>
                        <a:t>† </a:t>
                      </a:r>
                      <a:r>
                        <a:rPr lang="en-US" sz="600" b="0" i="0" u="none" strike="noStrike" dirty="0" err="1">
                          <a:latin typeface="Arial"/>
                        </a:rPr>
                        <a:t>Calcluated</a:t>
                      </a:r>
                      <a:r>
                        <a:rPr lang="en-US" sz="600" b="0" i="0" u="none" strike="noStrike" dirty="0">
                          <a:latin typeface="Arial"/>
                        </a:rPr>
                        <a:t> score based on halftime for dissociation of the peptide from HLA molecule [48].</a:t>
                      </a:r>
                    </a:p>
                  </a:txBody>
                  <a:tcPr marL="3277" marR="3277" marT="32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0188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 dirty="0">
                          <a:latin typeface="Times New Roman"/>
                        </a:rPr>
                        <a:t>*</a:t>
                      </a:r>
                      <a:r>
                        <a:rPr lang="en-US" sz="600" b="0" i="0" u="none" strike="noStrike" dirty="0">
                          <a:latin typeface="Arial"/>
                        </a:rPr>
                        <a:t>Binding affinity scores calculated using SYFPEITHI database [49].</a:t>
                      </a:r>
                      <a:endParaRPr lang="en-US" sz="600" b="0" i="0" u="none" strike="noStrike" dirty="0">
                        <a:latin typeface="Times New Roman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600" b="0" i="0" u="none" strike="noStrike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600" b="0" i="0" u="none" strike="noStrike" dirty="0">
                        <a:latin typeface="Arial"/>
                      </a:endParaRPr>
                    </a:p>
                  </a:txBody>
                  <a:tcPr marL="3277" marR="3277" marT="32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3" y="0"/>
            <a:ext cx="11465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itchFamily="34" charset="0"/>
                <a:cs typeface="Arial" pitchFamily="34" charset="0"/>
              </a:rPr>
              <a:t>Table S1: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Grayscale">
      <a:dk1>
        <a:sysClr val="windowText" lastClr="000000"/>
      </a:dk1>
      <a:lt1>
        <a:sysClr val="window" lastClr="FFFFFF"/>
      </a:lt1>
      <a:dk2>
        <a:srgbClr val="000000"/>
      </a:dk2>
      <a:lt2>
        <a:srgbClr val="F8F8F8"/>
      </a:lt2>
      <a:accent1>
        <a:srgbClr val="DDDDDD"/>
      </a:accent1>
      <a:accent2>
        <a:srgbClr val="B2B2B2"/>
      </a:accent2>
      <a:accent3>
        <a:srgbClr val="969696"/>
      </a:accent3>
      <a:accent4>
        <a:srgbClr val="808080"/>
      </a:accent4>
      <a:accent5>
        <a:srgbClr val="5F5F5F"/>
      </a:accent5>
      <a:accent6>
        <a:srgbClr val="4D4D4D"/>
      </a:accent6>
      <a:hlink>
        <a:srgbClr val="5F5F5F"/>
      </a:hlink>
      <a:folHlink>
        <a:srgbClr val="919191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809</TotalTime>
  <Words>553</Words>
  <Application>Microsoft Office PowerPoint</Application>
  <PresentationFormat>On-screen Show (4:3)</PresentationFormat>
  <Paragraphs>40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James Testa</dc:creator>
  <cp:lastModifiedBy>James Testa</cp:lastModifiedBy>
  <cp:revision>90</cp:revision>
  <dcterms:created xsi:type="dcterms:W3CDTF">2012-03-13T17:54:53Z</dcterms:created>
  <dcterms:modified xsi:type="dcterms:W3CDTF">2012-07-06T15:55:54Z</dcterms:modified>
</cp:coreProperties>
</file>